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23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910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677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9751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864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32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529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7709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7123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0952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49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2288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0803F-D281-41CA-AF21-C2B4B81B44D0}" type="datetimeFigureOut">
              <a:rPr lang="en-GB" smtClean="0"/>
              <a:t>24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3F38D-3C59-4C44-AA44-F7CA8E940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253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2656" y="3131840"/>
            <a:ext cx="625212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. 1.</a:t>
            </a:r>
          </a:p>
          <a:p>
            <a:pPr algn="just"/>
            <a:r>
              <a:rPr lang="en-GB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Virulence of control viruses in the intradermal model.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oups of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ree C57BL/6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ce were inoculated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.d.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both ear pinnae with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p.f.u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of the previously published single deletion viruses and their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vertant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s (a) or the viruses and their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vertant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s constructed for this study (b). The resulting lesions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were measured daily. Data are expressed as the mean lesion size (mm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± SEM. Data are from a single experiment.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0648" y="314236"/>
            <a:ext cx="480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84984" y="314003"/>
            <a:ext cx="5303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4834618"/>
              </p:ext>
            </p:extLst>
          </p:nvPr>
        </p:nvGraphicFramePr>
        <p:xfrm>
          <a:off x="116632" y="579307"/>
          <a:ext cx="3312368" cy="2674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Project" r:id="rId3" imgW="5616000" imgH="4536000" progId="Prism5.Document">
                  <p:embed/>
                </p:oleObj>
              </mc:Choice>
              <mc:Fallback>
                <p:oleObj name="Prism Project" r:id="rId3" imgW="5616000" imgH="453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6632" y="579307"/>
                        <a:ext cx="3312368" cy="26747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8842260"/>
              </p:ext>
            </p:extLst>
          </p:nvPr>
        </p:nvGraphicFramePr>
        <p:xfrm>
          <a:off x="3315131" y="547503"/>
          <a:ext cx="3501591" cy="2736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Project" r:id="rId5" imgW="6588000" imgH="5148000" progId="Prism5.Document">
                  <p:embed/>
                </p:oleObj>
              </mc:Choice>
              <mc:Fallback>
                <p:oleObj name="Prism Project" r:id="rId5" imgW="6588000" imgH="514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15131" y="547503"/>
                        <a:ext cx="3501591" cy="2736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5618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0648" y="5652120"/>
            <a:ext cx="625212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. 2.</a:t>
            </a:r>
            <a:r>
              <a:rPr lang="en-GB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 smtClean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mmunogenicity </a:t>
            </a:r>
            <a:r>
              <a:rPr lang="en-GB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of control viruses used in this study.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oups of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ree C57BL/6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ce were vaccinated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.d.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both ear pinnae with the previously published single deletion viruses and their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vertant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s (a) or the viruses and their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vertant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s constructed for this study (b) and then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hallenge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.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1 month later with a lethal dose of wild-type WR (5×10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p.f.u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sulting weight loss was monitored daily. Data are expressed as the percentage ± SEM of the mean weight of the same group of animals on day 0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Data are from a single experiment.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0648" y="314236"/>
            <a:ext cx="480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9918" y="2950054"/>
            <a:ext cx="5303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7964070"/>
              </p:ext>
            </p:extLst>
          </p:nvPr>
        </p:nvGraphicFramePr>
        <p:xfrm>
          <a:off x="-1179513" y="100273"/>
          <a:ext cx="6120681" cy="2815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Project" r:id="rId3" imgW="6574320" imgH="3026520" progId="Prism5.Document">
                  <p:embed/>
                </p:oleObj>
              </mc:Choice>
              <mc:Fallback>
                <p:oleObj name="Prism Project" r:id="rId3" imgW="6574320" imgH="30265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179513" y="100273"/>
                        <a:ext cx="6120681" cy="28155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9611637"/>
              </p:ext>
            </p:extLst>
          </p:nvPr>
        </p:nvGraphicFramePr>
        <p:xfrm>
          <a:off x="44624" y="3174702"/>
          <a:ext cx="4052894" cy="25494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Project" r:id="rId5" imgW="4176000" imgH="2628000" progId="Prism5.Document">
                  <p:embed/>
                </p:oleObj>
              </mc:Choice>
              <mc:Fallback>
                <p:oleObj name="Prism Project" r:id="rId5" imgW="417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624" y="3174702"/>
                        <a:ext cx="4052894" cy="25494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63444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12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Office Theme</vt:lpstr>
      <vt:lpstr>Prism Project</vt:lpstr>
      <vt:lpstr>GraphPad Prism 5 Project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cky</dc:creator>
  <cp:lastModifiedBy>Becky</cp:lastModifiedBy>
  <cp:revision>4</cp:revision>
  <dcterms:created xsi:type="dcterms:W3CDTF">2015-08-31T10:52:38Z</dcterms:created>
  <dcterms:modified xsi:type="dcterms:W3CDTF">2016-04-24T11:57:24Z</dcterms:modified>
</cp:coreProperties>
</file>